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61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6E943017-D3DE-4C49-BAD4-25EFFDBB32E4}" v="1" dt="2024-10-10T06:51:07.348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2934" autoAdjust="0"/>
    <p:restoredTop sz="94660"/>
  </p:normalViewPr>
  <p:slideViewPr>
    <p:cSldViewPr snapToGrid="0">
      <p:cViewPr varScale="1">
        <p:scale>
          <a:sx n="73" d="100"/>
          <a:sy n="73" d="100"/>
        </p:scale>
        <p:origin x="1908" y="6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microsoft.com/office/2015/10/relationships/revisionInfo" Target="revisionInfo.xml"/><Relationship Id="rId3" Type="http://schemas.openxmlformats.org/officeDocument/2006/relationships/presProps" Target="presProps.xml"/><Relationship Id="rId7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赤堀　ゆきこ" userId="bbfeda90-9ade-440e-995a-5a1e8cff3baf" providerId="ADAL" clId="{EEB7F054-3BFF-465B-A806-FD689B1075A7}"/>
    <pc:docChg chg="modSld">
      <pc:chgData name="赤堀　ゆきこ" userId="bbfeda90-9ade-440e-995a-5a1e8cff3baf" providerId="ADAL" clId="{EEB7F054-3BFF-465B-A806-FD689B1075A7}" dt="2024-10-10T07:06:37.944" v="3" actId="12788"/>
      <pc:docMkLst>
        <pc:docMk/>
      </pc:docMkLst>
      <pc:sldChg chg="modSp mod">
        <pc:chgData name="赤堀　ゆきこ" userId="bbfeda90-9ade-440e-995a-5a1e8cff3baf" providerId="ADAL" clId="{EEB7F054-3BFF-465B-A806-FD689B1075A7}" dt="2024-10-10T07:06:37.944" v="3" actId="12788"/>
        <pc:sldMkLst>
          <pc:docMk/>
          <pc:sldMk cId="3223437358" sldId="261"/>
        </pc:sldMkLst>
        <pc:spChg chg="mod">
          <ac:chgData name="赤堀　ゆきこ" userId="bbfeda90-9ade-440e-995a-5a1e8cff3baf" providerId="ADAL" clId="{EEB7F054-3BFF-465B-A806-FD689B1075A7}" dt="2024-10-10T07:06:27.999" v="0" actId="255"/>
          <ac:spMkLst>
            <pc:docMk/>
            <pc:sldMk cId="3223437358" sldId="261"/>
            <ac:spMk id="5" creationId="{1077F836-F8F0-C8B0-A602-8CAEAED7357E}"/>
          </ac:spMkLst>
        </pc:spChg>
        <pc:graphicFrameChg chg="mod modGraphic">
          <ac:chgData name="赤堀　ゆきこ" userId="bbfeda90-9ade-440e-995a-5a1e8cff3baf" providerId="ADAL" clId="{EEB7F054-3BFF-465B-A806-FD689B1075A7}" dt="2024-10-10T07:06:37.944" v="3" actId="12788"/>
          <ac:graphicFrameMkLst>
            <pc:docMk/>
            <pc:sldMk cId="3223437358" sldId="261"/>
            <ac:graphicFrameMk id="4" creationId="{5D8EE5DF-E8F6-36B1-94AD-C440A19102F6}"/>
          </ac:graphicFrameMkLst>
        </pc:graphicFrame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2E0BBB-3399-4401-875A-1370C28E4E37}" type="datetimeFigureOut">
              <a:rPr kumimoji="1" lang="ja-JP" altLang="en-US" smtClean="0"/>
              <a:t>2024/10/1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CA8580-E68A-4957-9555-572C0B1A605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5722787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2E0BBB-3399-4401-875A-1370C28E4E37}" type="datetimeFigureOut">
              <a:rPr kumimoji="1" lang="ja-JP" altLang="en-US" smtClean="0"/>
              <a:t>2024/10/1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CA8580-E68A-4957-9555-572C0B1A605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1894986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2E0BBB-3399-4401-875A-1370C28E4E37}" type="datetimeFigureOut">
              <a:rPr kumimoji="1" lang="ja-JP" altLang="en-US" smtClean="0"/>
              <a:t>2024/10/1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CA8580-E68A-4957-9555-572C0B1A605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2526214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2E0BBB-3399-4401-875A-1370C28E4E37}" type="datetimeFigureOut">
              <a:rPr kumimoji="1" lang="ja-JP" altLang="en-US" smtClean="0"/>
              <a:t>2024/10/1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CA8580-E68A-4957-9555-572C0B1A605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5538395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82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82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2E0BBB-3399-4401-875A-1370C28E4E37}" type="datetimeFigureOut">
              <a:rPr kumimoji="1" lang="ja-JP" altLang="en-US" smtClean="0"/>
              <a:t>2024/10/1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CA8580-E68A-4957-9555-572C0B1A605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1670646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2E0BBB-3399-4401-875A-1370C28E4E37}" type="datetimeFigureOut">
              <a:rPr kumimoji="1" lang="ja-JP" altLang="en-US" smtClean="0"/>
              <a:t>2024/10/10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CA8580-E68A-4957-9555-572C0B1A605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1263672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2E0BBB-3399-4401-875A-1370C28E4E37}" type="datetimeFigureOut">
              <a:rPr kumimoji="1" lang="ja-JP" altLang="en-US" smtClean="0"/>
              <a:t>2024/10/10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CA8580-E68A-4957-9555-572C0B1A605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763651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2E0BBB-3399-4401-875A-1370C28E4E37}" type="datetimeFigureOut">
              <a:rPr kumimoji="1" lang="ja-JP" altLang="en-US" smtClean="0"/>
              <a:t>2024/10/10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CA8580-E68A-4957-9555-572C0B1A605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0351028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2E0BBB-3399-4401-875A-1370C28E4E37}" type="datetimeFigureOut">
              <a:rPr kumimoji="1" lang="ja-JP" altLang="en-US" smtClean="0"/>
              <a:t>2024/10/10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CA8580-E68A-4957-9555-572C0B1A605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9961260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2E0BBB-3399-4401-875A-1370C28E4E37}" type="datetimeFigureOut">
              <a:rPr kumimoji="1" lang="ja-JP" altLang="en-US" smtClean="0"/>
              <a:t>2024/10/10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CA8580-E68A-4957-9555-572C0B1A605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8763989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2E0BBB-3399-4401-875A-1370C28E4E37}" type="datetimeFigureOut">
              <a:rPr kumimoji="1" lang="ja-JP" altLang="en-US" smtClean="0"/>
              <a:t>2024/10/10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CA8580-E68A-4957-9555-572C0B1A605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1061603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772E0BBB-3399-4401-875A-1370C28E4E37}" type="datetimeFigureOut">
              <a:rPr kumimoji="1" lang="ja-JP" altLang="en-US" smtClean="0"/>
              <a:t>2024/10/1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9CCA8580-E68A-4957-9555-572C0B1A605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6331476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表 3">
            <a:extLst>
              <a:ext uri="{FF2B5EF4-FFF2-40B4-BE49-F238E27FC236}">
                <a16:creationId xmlns:a16="http://schemas.microsoft.com/office/drawing/2014/main" id="{5D8EE5DF-E8F6-36B1-94AD-C440A19102F6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817140840"/>
              </p:ext>
            </p:extLst>
          </p:nvPr>
        </p:nvGraphicFramePr>
        <p:xfrm>
          <a:off x="1545824" y="3751773"/>
          <a:ext cx="3766353" cy="1228703"/>
        </p:xfrm>
        <a:graphic>
          <a:graphicData uri="http://schemas.openxmlformats.org/drawingml/2006/table">
            <a:tbl>
              <a:tblPr firstRow="1" firstCol="1">
                <a:tableStyleId>{9D7B26C5-4107-4FEC-AEDC-1716B250A1EF}</a:tableStyleId>
              </a:tblPr>
              <a:tblGrid>
                <a:gridCol w="851094">
                  <a:extLst>
                    <a:ext uri="{9D8B030D-6E8A-4147-A177-3AD203B41FA5}">
                      <a16:colId xmlns:a16="http://schemas.microsoft.com/office/drawing/2014/main" val="3904043092"/>
                    </a:ext>
                  </a:extLst>
                </a:gridCol>
                <a:gridCol w="1854498">
                  <a:extLst>
                    <a:ext uri="{9D8B030D-6E8A-4147-A177-3AD203B41FA5}">
                      <a16:colId xmlns:a16="http://schemas.microsoft.com/office/drawing/2014/main" val="4030888525"/>
                    </a:ext>
                  </a:extLst>
                </a:gridCol>
                <a:gridCol w="1060761">
                  <a:extLst>
                    <a:ext uri="{9D8B030D-6E8A-4147-A177-3AD203B41FA5}">
                      <a16:colId xmlns:a16="http://schemas.microsoft.com/office/drawing/2014/main" val="1133051810"/>
                    </a:ext>
                  </a:extLst>
                </a:gridCol>
              </a:tblGrid>
              <a:tr h="593669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erotype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12349" marR="12349" marT="1234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FLX</a:t>
                      </a:r>
                    </a:p>
                    <a:p>
                      <a:pPr algn="ctr" fontAlgn="ctr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Inhibitory zone (mm)</a:t>
                      </a:r>
                    </a:p>
                  </a:txBody>
                  <a:tcPr marL="12349" marR="12349" marT="1234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Interpretive</a:t>
                      </a:r>
                    </a:p>
                    <a:p>
                      <a:pPr algn="ctr" fontAlgn="ctr"/>
                      <a:r>
                        <a:rPr lang="en-US" altLang="ja-JP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category</a:t>
                      </a:r>
                      <a:endParaRPr lang="ja-JP" alt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12349" marR="12349" marT="12349" marB="0" anchor="ctr"/>
                </a:tc>
                <a:extLst>
                  <a:ext uri="{0D108BD9-81ED-4DB2-BD59-A6C34878D82A}">
                    <a16:rowId xmlns:a16="http://schemas.microsoft.com/office/drawing/2014/main" val="1757839188"/>
                  </a:ext>
                </a:extLst>
              </a:tr>
              <a:tr h="317517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12349" marR="12349" marT="1234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3</a:t>
                      </a:r>
                      <a:endParaRPr lang="en-US" altLang="ja-JP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12349" marR="12349" marT="1234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12349" marR="12349" marT="12349" marB="0" anchor="ctr"/>
                </a:tc>
                <a:extLst>
                  <a:ext uri="{0D108BD9-81ED-4DB2-BD59-A6C34878D82A}">
                    <a16:rowId xmlns:a16="http://schemas.microsoft.com/office/drawing/2014/main" val="2806069938"/>
                  </a:ext>
                </a:extLst>
              </a:tr>
              <a:tr h="317517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3</a:t>
                      </a:r>
                    </a:p>
                  </a:txBody>
                  <a:tcPr marL="12349" marR="12349" marT="1234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4</a:t>
                      </a:r>
                      <a:endParaRPr lang="en-US" altLang="ja-JP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12349" marR="12349" marT="1234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12349" marR="12349" marT="12349" marB="0" anchor="ctr"/>
                </a:tc>
                <a:extLst>
                  <a:ext uri="{0D108BD9-81ED-4DB2-BD59-A6C34878D82A}">
                    <a16:rowId xmlns:a16="http://schemas.microsoft.com/office/drawing/2014/main" val="588609367"/>
                  </a:ext>
                </a:extLst>
              </a:tr>
            </a:tbl>
          </a:graphicData>
        </a:graphic>
      </p:graphicFrame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1077F836-F8F0-C8B0-A602-8CAEAED7357E}"/>
              </a:ext>
            </a:extLst>
          </p:cNvPr>
          <p:cNvSpPr txBox="1"/>
          <p:nvPr/>
        </p:nvSpPr>
        <p:spPr>
          <a:xfrm>
            <a:off x="813777" y="3308100"/>
            <a:ext cx="2427716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S1 Table</a:t>
            </a:r>
          </a:p>
          <a:p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Inhibitory zone test against TFLX</a:t>
            </a:r>
            <a:endParaRPr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4468896E-99F7-B390-01A5-1AB8827CE026}"/>
              </a:ext>
            </a:extLst>
          </p:cNvPr>
          <p:cNvSpPr txBox="1"/>
          <p:nvPr/>
        </p:nvSpPr>
        <p:spPr>
          <a:xfrm>
            <a:off x="813777" y="2793452"/>
            <a:ext cx="1552028" cy="25513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58" dirty="0">
                <a:latin typeface="Arial" panose="020B0604020202020204" pitchFamily="34" charset="0"/>
                <a:cs typeface="Arial" panose="020B0604020202020204" pitchFamily="34" charset="0"/>
              </a:rPr>
              <a:t>Supporting information</a:t>
            </a:r>
            <a:endParaRPr lang="ja-JP" altLang="en-US" sz="1058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22343735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テーマ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</TotalTime>
  <Words>24</Words>
  <Application>Microsoft Office PowerPoint</Application>
  <PresentationFormat>A4 210 x 297 mm</PresentationFormat>
  <Paragraphs>14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5" baseType="lpstr">
      <vt:lpstr>Aptos</vt:lpstr>
      <vt:lpstr>Aptos Display</vt:lpstr>
      <vt:lpstr>Arial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赤堀　ゆきこ</dc:creator>
  <cp:lastModifiedBy>赤堀　ゆきこ</cp:lastModifiedBy>
  <cp:revision>7</cp:revision>
  <dcterms:created xsi:type="dcterms:W3CDTF">2024-10-10T06:46:11Z</dcterms:created>
  <dcterms:modified xsi:type="dcterms:W3CDTF">2024-10-10T07:06:38Z</dcterms:modified>
</cp:coreProperties>
</file>